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FCFDB-41B0-405C-9B96-16F4972BD5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A2BBE-CA33-4DF2-AEE7-7639325FBF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271E5-C84A-484A-8E9E-4727B0491E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913CC-932C-4335-BE01-4DC207F0E8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A4789-0D7D-4868-9731-56D7411FB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B8EA4-514A-4453-A354-26263C0A5A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D3C51-CFC3-4FCF-BEE3-525336250E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CBB4E1-2C5A-46B2-8B14-77C7CE0890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D4581-6E42-43DB-80CE-2C0A44F52C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C5F84-C180-4775-8CA0-A2FB13432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327B6-C804-4C8C-84C0-07151A1C6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7A1A9-BE00-48F4-8440-DF08BF406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EA22E59-A597-4818-9F57-213E4B4D5D36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C7E97BA-D19A-40A6-B3B8-6E9C94AA8A2B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18"/>
          <p:cNvGrpSpPr/>
          <p:nvPr/>
        </p:nvGrpSpPr>
        <p:grpSpPr>
          <a:xfrm>
            <a:off x="1353240" y="825480"/>
            <a:ext cx="6315840" cy="2541600"/>
            <a:chOff x="1353240" y="825480"/>
            <a:chExt cx="6315840" cy="2541600"/>
          </a:xfrm>
        </p:grpSpPr>
        <p:sp>
          <p:nvSpPr>
            <p:cNvPr id="42" name="CasellaDiTesto 43"/>
            <p:cNvSpPr/>
            <p:nvPr/>
          </p:nvSpPr>
          <p:spPr>
            <a:xfrm>
              <a:off x="3271680" y="1419120"/>
              <a:ext cx="1857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wt            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tH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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6" descr=""/>
            <p:cNvPicPr/>
            <p:nvPr/>
          </p:nvPicPr>
          <p:blipFill>
            <a:blip r:embed="rId1"/>
            <a:srcRect l="0" t="4918" r="7797" b="12096"/>
            <a:stretch/>
          </p:blipFill>
          <p:spPr>
            <a:xfrm>
              <a:off x="5494320" y="2527200"/>
              <a:ext cx="2174760" cy="839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"/>
            <p:cNvPicPr/>
            <p:nvPr/>
          </p:nvPicPr>
          <p:blipFill>
            <a:blip r:embed="rId2"/>
            <a:srcRect l="0" t="16625" r="10171" b="16625"/>
            <a:stretch/>
          </p:blipFill>
          <p:spPr>
            <a:xfrm>
              <a:off x="3127320" y="2524320"/>
              <a:ext cx="2144520" cy="83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CasellaDiTesto 43"/>
            <p:cNvSpPr/>
            <p:nvPr/>
          </p:nvSpPr>
          <p:spPr>
            <a:xfrm>
              <a:off x="5576760" y="1423800"/>
              <a:ext cx="1857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wt              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tH  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</a:t>
              </a:r>
              <a:r>
                <a:rPr b="1" i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uppo 7"/>
            <p:cNvGrpSpPr/>
            <p:nvPr/>
          </p:nvGrpSpPr>
          <p:grpSpPr>
            <a:xfrm>
              <a:off x="2550240" y="2828880"/>
              <a:ext cx="541800" cy="261360"/>
              <a:chOff x="2550240" y="2828880"/>
              <a:chExt cx="541800" cy="261360"/>
            </a:xfrm>
          </p:grpSpPr>
          <p:sp>
            <p:nvSpPr>
              <p:cNvPr id="47" name="TextBox 42"/>
              <p:cNvSpPr/>
              <p:nvPr/>
            </p:nvSpPr>
            <p:spPr>
              <a:xfrm>
                <a:off x="2550240" y="2828880"/>
                <a:ext cx="541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24kDa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8" name="Connettore 2 9"/>
              <p:cNvCxnSpPr/>
              <p:nvPr/>
            </p:nvCxnSpPr>
            <p:spPr>
              <a:xfrm>
                <a:off x="3026520" y="2960280"/>
                <a:ext cx="60840" cy="108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49" name="CasellaDiTesto 3"/>
            <p:cNvSpPr/>
            <p:nvPr/>
          </p:nvSpPr>
          <p:spPr>
            <a:xfrm>
              <a:off x="1359000" y="2791080"/>
              <a:ext cx="8834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Anti-Cot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11" descr=""/>
            <p:cNvPicPr/>
            <p:nvPr/>
          </p:nvPicPr>
          <p:blipFill>
            <a:blip r:embed="rId3"/>
            <a:stretch/>
          </p:blipFill>
          <p:spPr>
            <a:xfrm>
              <a:off x="3087360" y="1701720"/>
              <a:ext cx="2144520" cy="53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2" descr=""/>
            <p:cNvPicPr/>
            <p:nvPr/>
          </p:nvPicPr>
          <p:blipFill>
            <a:blip r:embed="rId4"/>
            <a:stretch/>
          </p:blipFill>
          <p:spPr>
            <a:xfrm>
              <a:off x="5472000" y="1695240"/>
              <a:ext cx="2176560" cy="520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Gruppo 13"/>
            <p:cNvGrpSpPr/>
            <p:nvPr/>
          </p:nvGrpSpPr>
          <p:grpSpPr>
            <a:xfrm>
              <a:off x="2558160" y="1817640"/>
              <a:ext cx="541800" cy="261360"/>
              <a:chOff x="2558160" y="1817640"/>
              <a:chExt cx="541800" cy="261360"/>
            </a:xfrm>
          </p:grpSpPr>
          <p:sp>
            <p:nvSpPr>
              <p:cNvPr id="53" name="TextBox 42"/>
              <p:cNvSpPr/>
              <p:nvPr/>
            </p:nvSpPr>
            <p:spPr>
              <a:xfrm>
                <a:off x="2558160" y="1817640"/>
                <a:ext cx="541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it-IT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42kDa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54" name="Connettore 2 15"/>
              <p:cNvCxnSpPr/>
              <p:nvPr/>
            </p:nvCxnSpPr>
            <p:spPr>
              <a:xfrm>
                <a:off x="3034440" y="1949040"/>
                <a:ext cx="59400" cy="108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55" name="CasellaDiTesto 3"/>
            <p:cNvSpPr/>
            <p:nvPr/>
          </p:nvSpPr>
          <p:spPr>
            <a:xfrm>
              <a:off x="1353240" y="1825560"/>
              <a:ext cx="90936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Anti-Cot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CasellaDiTesto 1"/>
            <p:cNvSpPr/>
            <p:nvPr/>
          </p:nvSpPr>
          <p:spPr>
            <a:xfrm>
              <a:off x="5871240" y="825480"/>
              <a:ext cx="863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Decoat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extrac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ttangolo 18"/>
            <p:cNvSpPr/>
            <p:nvPr/>
          </p:nvSpPr>
          <p:spPr>
            <a:xfrm>
              <a:off x="3474720" y="825480"/>
              <a:ext cx="145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SDS-DTT extrac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Box 75"/>
          <p:cNvSpPr/>
          <p:nvPr/>
        </p:nvSpPr>
        <p:spPr>
          <a:xfrm>
            <a:off x="411120" y="4043520"/>
            <a:ext cx="8377200" cy="14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1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otH  is not part of the insoluble coat protein fraction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estern blot of coat proteins extracted from mature spores of a wild type strain and isogenic strains lacking CotH (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otH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) or CotE (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otE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). Extraction was carried out either by standard SDS-DTT treatment [Cutting, Vander Horn, 1990] or by a decoating procedure developed to extract the insoluble coat protein fraction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[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epachedu and Setlow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2005]. The amount of CotH extracted by the two methods is almost identical, suggesting that CotH is not part of the insoluble coat fraction. In strain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otE</a:t>
            </a:r>
            <a:r>
              <a:rPr b="0" lang="it-IT" sz="1100" spc="-1" strike="noStrike">
                <a:solidFill>
                  <a:srgbClr val="000000"/>
                </a:solidFill>
                <a:latin typeface="Arial"/>
                <a:ea typeface="Arial"/>
              </a:rPr>
              <a:t>,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CotH was not found confirming its dependence on CotE [Zilhao et al., 1999]. CotE was extracted in a slightly higher amount by the decoat method than by the standard SDS-DTT treatment, suggesting that it is partially insolubl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9T16:44:58Z</dcterms:created>
  <dc:creator>Ezio Ricca</dc:creator>
  <dc:description/>
  <dc:language>en-US</dc:language>
  <cp:lastModifiedBy>Scott</cp:lastModifiedBy>
  <dcterms:modified xsi:type="dcterms:W3CDTF">2013-09-10T07:43:00Z</dcterms:modified>
  <cp:revision>8</cp:revision>
  <dc:subject/>
  <dc:title>Slide 1</dc:title>
</cp:coreProperties>
</file>